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74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427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892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0352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853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8784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955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821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1876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0346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000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9659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D49DC2-D4BC-4136-90A4-446F4B9934F6}" type="datetimeFigureOut">
              <a:rPr lang="ko-KR" altLang="en-US" smtClean="0"/>
              <a:t>2020-06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0FB77-28D6-4963-8ACA-91ECD9ABD0A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7698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493818"/>
              </p:ext>
            </p:extLst>
          </p:nvPr>
        </p:nvGraphicFramePr>
        <p:xfrm>
          <a:off x="1349375" y="842963"/>
          <a:ext cx="6530975" cy="4760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SPW 12.0 Graph" r:id="rId3" imgW="4781486" imgH="3486252" progId="SigmaPlotGraphicObject.11">
                  <p:embed/>
                </p:oleObj>
              </mc:Choice>
              <mc:Fallback>
                <p:oleObj name="SPW 12.0 Graph" r:id="rId3" imgW="4781486" imgH="3486252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49375" y="842963"/>
                        <a:ext cx="6530975" cy="4760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485505" y="5204227"/>
            <a:ext cx="517051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CHF      Dem     DM1     DM2    Ren       Mal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18755" y="3591099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.72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02922" y="3721285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.59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087088" y="3827976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.51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876799" y="3485851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.82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77592" y="2963319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.29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458990" y="3798461"/>
            <a:ext cx="739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.52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1397" y="108755"/>
            <a:ext cx="90276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. 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dds ratio and 95% confidence interval for mortality during treatment for COVID-19 according to the type of underlying diseases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206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37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SPW 12.0 Graph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7</cp:revision>
  <dcterms:created xsi:type="dcterms:W3CDTF">2020-06-01T08:26:43Z</dcterms:created>
  <dcterms:modified xsi:type="dcterms:W3CDTF">2020-06-10T01:46:45Z</dcterms:modified>
</cp:coreProperties>
</file>